
<file path=[Content_Types].xml><?xml version="1.0" encoding="utf-8"?>
<Types xmlns="http://schemas.openxmlformats.org/package/2006/content-types">
  <Default Extension="bmp" ContentType="image/bmp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7"/>
  </p:notesMasterIdLst>
  <p:sldIdLst>
    <p:sldId id="260" r:id="rId2"/>
    <p:sldId id="263" r:id="rId3"/>
    <p:sldId id="266" r:id="rId4"/>
    <p:sldId id="264" r:id="rId5"/>
    <p:sldId id="265" r:id="rId6"/>
  </p:sldIdLst>
  <p:sldSz cx="16256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8A041833-A45C-4D5C-9C03-8F95B93AA73B}" v="61" dt="2022-12-21T15:21:33.956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8EC20E35-A176-4012-BC5E-935CFFF8708E}" styleName="Medium Style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803" autoAdjust="0"/>
    <p:restoredTop sz="79796" autoAdjust="0"/>
  </p:normalViewPr>
  <p:slideViewPr>
    <p:cSldViewPr snapToGrid="0">
      <p:cViewPr varScale="1">
        <p:scale>
          <a:sx n="81" d="100"/>
          <a:sy n="81" d="100"/>
        </p:scale>
        <p:origin x="2442" y="12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13" Type="http://schemas.microsoft.com/office/2015/10/relationships/revisionInfo" Target="revisionInfo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12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Woon, Ee Von" userId="1b3820bb-7f14-49a5-83eb-04a96bcdd0d6" providerId="ADAL" clId="{8A041833-A45C-4D5C-9C03-8F95B93AA73B}"/>
    <pc:docChg chg="undo custSel addSld delSld modSld">
      <pc:chgData name="Woon, Ee Von" userId="1b3820bb-7f14-49a5-83eb-04a96bcdd0d6" providerId="ADAL" clId="{8A041833-A45C-4D5C-9C03-8F95B93AA73B}" dt="2022-12-21T16:44:01.039" v="1934" actId="20577"/>
      <pc:docMkLst>
        <pc:docMk/>
      </pc:docMkLst>
      <pc:sldChg chg="del">
        <pc:chgData name="Woon, Ee Von" userId="1b3820bb-7f14-49a5-83eb-04a96bcdd0d6" providerId="ADAL" clId="{8A041833-A45C-4D5C-9C03-8F95B93AA73B}" dt="2022-11-25T08:57:29.113" v="0" actId="47"/>
        <pc:sldMkLst>
          <pc:docMk/>
          <pc:sldMk cId="2693354222" sldId="256"/>
        </pc:sldMkLst>
      </pc:sldChg>
      <pc:sldChg chg="del">
        <pc:chgData name="Woon, Ee Von" userId="1b3820bb-7f14-49a5-83eb-04a96bcdd0d6" providerId="ADAL" clId="{8A041833-A45C-4D5C-9C03-8F95B93AA73B}" dt="2022-11-25T08:57:29.113" v="0" actId="47"/>
        <pc:sldMkLst>
          <pc:docMk/>
          <pc:sldMk cId="3309172584" sldId="257"/>
        </pc:sldMkLst>
      </pc:sldChg>
      <pc:sldChg chg="del">
        <pc:chgData name="Woon, Ee Von" userId="1b3820bb-7f14-49a5-83eb-04a96bcdd0d6" providerId="ADAL" clId="{8A041833-A45C-4D5C-9C03-8F95B93AA73B}" dt="2022-11-25T08:57:29.113" v="0" actId="47"/>
        <pc:sldMkLst>
          <pc:docMk/>
          <pc:sldMk cId="3410195590" sldId="258"/>
        </pc:sldMkLst>
      </pc:sldChg>
      <pc:sldChg chg="addSp delSp modSp mod modNotesTx">
        <pc:chgData name="Woon, Ee Von" userId="1b3820bb-7f14-49a5-83eb-04a96bcdd0d6" providerId="ADAL" clId="{8A041833-A45C-4D5C-9C03-8F95B93AA73B}" dt="2022-12-21T13:49:53.461" v="1808" actId="20577"/>
        <pc:sldMkLst>
          <pc:docMk/>
          <pc:sldMk cId="1284882319" sldId="260"/>
        </pc:sldMkLst>
        <pc:picChg chg="add del mod">
          <ac:chgData name="Woon, Ee Von" userId="1b3820bb-7f14-49a5-83eb-04a96bcdd0d6" providerId="ADAL" clId="{8A041833-A45C-4D5C-9C03-8F95B93AA73B}" dt="2022-12-21T13:47:50.507" v="1763" actId="478"/>
          <ac:picMkLst>
            <pc:docMk/>
            <pc:sldMk cId="1284882319" sldId="260"/>
            <ac:picMk id="3" creationId="{0D082339-754C-E4E4-7ED4-D787AEFC9B42}"/>
          </ac:picMkLst>
        </pc:picChg>
        <pc:picChg chg="del">
          <ac:chgData name="Woon, Ee Von" userId="1b3820bb-7f14-49a5-83eb-04a96bcdd0d6" providerId="ADAL" clId="{8A041833-A45C-4D5C-9C03-8F95B93AA73B}" dt="2022-12-21T13:44:19.385" v="1730" actId="478"/>
          <ac:picMkLst>
            <pc:docMk/>
            <pc:sldMk cId="1284882319" sldId="260"/>
            <ac:picMk id="4" creationId="{8873C956-292D-78A3-6C70-CAD130CD7333}"/>
          </ac:picMkLst>
        </pc:picChg>
        <pc:picChg chg="add del mod">
          <ac:chgData name="Woon, Ee Von" userId="1b3820bb-7f14-49a5-83eb-04a96bcdd0d6" providerId="ADAL" clId="{8A041833-A45C-4D5C-9C03-8F95B93AA73B}" dt="2022-12-21T13:48:14.198" v="1767" actId="478"/>
          <ac:picMkLst>
            <pc:docMk/>
            <pc:sldMk cId="1284882319" sldId="260"/>
            <ac:picMk id="6" creationId="{E790D2D1-634C-1226-724C-ADF0347575F5}"/>
          </ac:picMkLst>
        </pc:picChg>
        <pc:picChg chg="add del mod">
          <ac:chgData name="Woon, Ee Von" userId="1b3820bb-7f14-49a5-83eb-04a96bcdd0d6" providerId="ADAL" clId="{8A041833-A45C-4D5C-9C03-8F95B93AA73B}" dt="2022-12-21T13:48:31.556" v="1770" actId="478"/>
          <ac:picMkLst>
            <pc:docMk/>
            <pc:sldMk cId="1284882319" sldId="260"/>
            <ac:picMk id="8" creationId="{EA4BE6A0-1A4E-A563-B492-5D128D0CE436}"/>
          </ac:picMkLst>
        </pc:picChg>
        <pc:picChg chg="add mod">
          <ac:chgData name="Woon, Ee Von" userId="1b3820bb-7f14-49a5-83eb-04a96bcdd0d6" providerId="ADAL" clId="{8A041833-A45C-4D5C-9C03-8F95B93AA73B}" dt="2022-12-21T13:48:48.676" v="1772" actId="27614"/>
          <ac:picMkLst>
            <pc:docMk/>
            <pc:sldMk cId="1284882319" sldId="260"/>
            <ac:picMk id="10" creationId="{27F1E9CB-FE72-8365-DC7F-923727905F99}"/>
          </ac:picMkLst>
        </pc:picChg>
      </pc:sldChg>
      <pc:sldChg chg="addSp delSp modSp add del mod">
        <pc:chgData name="Woon, Ee Von" userId="1b3820bb-7f14-49a5-83eb-04a96bcdd0d6" providerId="ADAL" clId="{8A041833-A45C-4D5C-9C03-8F95B93AA73B}" dt="2022-12-21T11:54:27.097" v="348" actId="2696"/>
        <pc:sldMkLst>
          <pc:docMk/>
          <pc:sldMk cId="4255804134" sldId="261"/>
        </pc:sldMkLst>
        <pc:graphicFrameChg chg="add del mod modGraphic">
          <ac:chgData name="Woon, Ee Von" userId="1b3820bb-7f14-49a5-83eb-04a96bcdd0d6" providerId="ADAL" clId="{8A041833-A45C-4D5C-9C03-8F95B93AA73B}" dt="2022-12-21T11:15:34.781" v="168" actId="21"/>
          <ac:graphicFrameMkLst>
            <pc:docMk/>
            <pc:sldMk cId="4255804134" sldId="261"/>
            <ac:graphicFrameMk id="2" creationId="{4C726EEF-4884-227B-13D7-C687E98CB131}"/>
          </ac:graphicFrameMkLst>
        </pc:graphicFrameChg>
      </pc:sldChg>
      <pc:sldChg chg="del">
        <pc:chgData name="Woon, Ee Von" userId="1b3820bb-7f14-49a5-83eb-04a96bcdd0d6" providerId="ADAL" clId="{8A041833-A45C-4D5C-9C03-8F95B93AA73B}" dt="2022-11-25T08:57:29.113" v="0" actId="47"/>
        <pc:sldMkLst>
          <pc:docMk/>
          <pc:sldMk cId="1208736270" sldId="262"/>
        </pc:sldMkLst>
      </pc:sldChg>
      <pc:sldChg chg="addSp delSp modSp mod modNotesTx">
        <pc:chgData name="Woon, Ee Von" userId="1b3820bb-7f14-49a5-83eb-04a96bcdd0d6" providerId="ADAL" clId="{8A041833-A45C-4D5C-9C03-8F95B93AA73B}" dt="2022-12-21T14:50:04.888" v="1848" actId="20577"/>
        <pc:sldMkLst>
          <pc:docMk/>
          <pc:sldMk cId="1481780983" sldId="263"/>
        </pc:sldMkLst>
        <pc:picChg chg="add del mod">
          <ac:chgData name="Woon, Ee Von" userId="1b3820bb-7f14-49a5-83eb-04a96bcdd0d6" providerId="ADAL" clId="{8A041833-A45C-4D5C-9C03-8F95B93AA73B}" dt="2022-12-21T14:47:14.089" v="1813" actId="478"/>
          <ac:picMkLst>
            <pc:docMk/>
            <pc:sldMk cId="1481780983" sldId="263"/>
            <ac:picMk id="3" creationId="{92ADA75C-150F-AF58-3AA9-647DFBBBF4D4}"/>
          </ac:picMkLst>
        </pc:picChg>
        <pc:picChg chg="add del mod">
          <ac:chgData name="Woon, Ee Von" userId="1b3820bb-7f14-49a5-83eb-04a96bcdd0d6" providerId="ADAL" clId="{8A041833-A45C-4D5C-9C03-8F95B93AA73B}" dt="2022-12-21T14:49:37.144" v="1823" actId="478"/>
          <ac:picMkLst>
            <pc:docMk/>
            <pc:sldMk cId="1481780983" sldId="263"/>
            <ac:picMk id="5" creationId="{D5C0C43C-0A06-C3AD-C812-25C11FBFF844}"/>
          </ac:picMkLst>
        </pc:picChg>
        <pc:picChg chg="add mod">
          <ac:chgData name="Woon, Ee Von" userId="1b3820bb-7f14-49a5-83eb-04a96bcdd0d6" providerId="ADAL" clId="{8A041833-A45C-4D5C-9C03-8F95B93AA73B}" dt="2022-12-21T14:49:51.955" v="1826" actId="962"/>
          <ac:picMkLst>
            <pc:docMk/>
            <pc:sldMk cId="1481780983" sldId="263"/>
            <ac:picMk id="7" creationId="{7C0845A5-0CB7-D9AF-760C-E780B806C44D}"/>
          </ac:picMkLst>
        </pc:picChg>
        <pc:picChg chg="del">
          <ac:chgData name="Woon, Ee Von" userId="1b3820bb-7f14-49a5-83eb-04a96bcdd0d6" providerId="ADAL" clId="{8A041833-A45C-4D5C-9C03-8F95B93AA73B}" dt="2022-12-21T14:47:15.209" v="1814" actId="478"/>
          <ac:picMkLst>
            <pc:docMk/>
            <pc:sldMk cId="1481780983" sldId="263"/>
            <ac:picMk id="8" creationId="{687CE731-0723-70A3-B807-69FF174C3E05}"/>
          </ac:picMkLst>
        </pc:picChg>
      </pc:sldChg>
      <pc:sldChg chg="addSp delSp modSp new mod modNotesTx">
        <pc:chgData name="Woon, Ee Von" userId="1b3820bb-7f14-49a5-83eb-04a96bcdd0d6" providerId="ADAL" clId="{8A041833-A45C-4D5C-9C03-8F95B93AA73B}" dt="2022-12-21T15:21:51.609" v="1873" actId="1076"/>
        <pc:sldMkLst>
          <pc:docMk/>
          <pc:sldMk cId="3636912337" sldId="264"/>
        </pc:sldMkLst>
        <pc:picChg chg="add del mod">
          <ac:chgData name="Woon, Ee Von" userId="1b3820bb-7f14-49a5-83eb-04a96bcdd0d6" providerId="ADAL" clId="{8A041833-A45C-4D5C-9C03-8F95B93AA73B}" dt="2022-12-21T15:21:24.539" v="1852" actId="478"/>
          <ac:picMkLst>
            <pc:docMk/>
            <pc:sldMk cId="3636912337" sldId="264"/>
            <ac:picMk id="3" creationId="{67A03509-702A-CCB1-1C5B-CFE6CF918523}"/>
          </ac:picMkLst>
        </pc:picChg>
        <pc:picChg chg="add mod">
          <ac:chgData name="Woon, Ee Von" userId="1b3820bb-7f14-49a5-83eb-04a96bcdd0d6" providerId="ADAL" clId="{8A041833-A45C-4D5C-9C03-8F95B93AA73B}" dt="2022-12-21T15:21:51.609" v="1873" actId="1076"/>
          <ac:picMkLst>
            <pc:docMk/>
            <pc:sldMk cId="3636912337" sldId="264"/>
            <ac:picMk id="5" creationId="{D97E3118-4F65-DB5C-4D39-39CC0EB033E7}"/>
          </ac:picMkLst>
        </pc:picChg>
      </pc:sldChg>
      <pc:sldChg chg="new del">
        <pc:chgData name="Woon, Ee Von" userId="1b3820bb-7f14-49a5-83eb-04a96bcdd0d6" providerId="ADAL" clId="{8A041833-A45C-4D5C-9C03-8F95B93AA73B}" dt="2022-12-21T11:15:32.929" v="166" actId="680"/>
        <pc:sldMkLst>
          <pc:docMk/>
          <pc:sldMk cId="1068553458" sldId="265"/>
        </pc:sldMkLst>
      </pc:sldChg>
      <pc:sldChg chg="addSp modSp new mod modNotesTx">
        <pc:chgData name="Woon, Ee Von" userId="1b3820bb-7f14-49a5-83eb-04a96bcdd0d6" providerId="ADAL" clId="{8A041833-A45C-4D5C-9C03-8F95B93AA73B}" dt="2022-12-21T16:44:01.039" v="1934" actId="20577"/>
        <pc:sldMkLst>
          <pc:docMk/>
          <pc:sldMk cId="3673804231" sldId="265"/>
        </pc:sldMkLst>
        <pc:graphicFrameChg chg="add mod modGraphic">
          <ac:chgData name="Woon, Ee Von" userId="1b3820bb-7f14-49a5-83eb-04a96bcdd0d6" providerId="ADAL" clId="{8A041833-A45C-4D5C-9C03-8F95B93AA73B}" dt="2022-12-21T15:07:02.456" v="1849" actId="14100"/>
          <ac:graphicFrameMkLst>
            <pc:docMk/>
            <pc:sldMk cId="3673804231" sldId="265"/>
            <ac:graphicFrameMk id="2" creationId="{8C1537B2-D6AB-7222-CF09-1746BE4CC8AC}"/>
          </ac:graphicFrameMkLst>
        </pc:graphicFrameChg>
      </pc:sldChg>
      <pc:sldChg chg="addSp delSp modSp new mod modNotesTx">
        <pc:chgData name="Woon, Ee Von" userId="1b3820bb-7f14-49a5-83eb-04a96bcdd0d6" providerId="ADAL" clId="{8A041833-A45C-4D5C-9C03-8F95B93AA73B}" dt="2022-12-21T16:43:33.887" v="1905" actId="20577"/>
        <pc:sldMkLst>
          <pc:docMk/>
          <pc:sldMk cId="2220380472" sldId="266"/>
        </pc:sldMkLst>
        <pc:picChg chg="add del mod">
          <ac:chgData name="Woon, Ee Von" userId="1b3820bb-7f14-49a5-83eb-04a96bcdd0d6" providerId="ADAL" clId="{8A041833-A45C-4D5C-9C03-8F95B93AA73B}" dt="2022-12-21T12:42:11.122" v="1171" actId="478"/>
          <ac:picMkLst>
            <pc:docMk/>
            <pc:sldMk cId="2220380472" sldId="266"/>
            <ac:picMk id="3" creationId="{69C73E4F-C02F-97B6-4C6C-7FB67DD5012A}"/>
          </ac:picMkLst>
        </pc:picChg>
        <pc:picChg chg="add del mod">
          <ac:chgData name="Woon, Ee Von" userId="1b3820bb-7f14-49a5-83eb-04a96bcdd0d6" providerId="ADAL" clId="{8A041833-A45C-4D5C-9C03-8F95B93AA73B}" dt="2022-12-21T12:54:14.908" v="1724" actId="478"/>
          <ac:picMkLst>
            <pc:docMk/>
            <pc:sldMk cId="2220380472" sldId="266"/>
            <ac:picMk id="5" creationId="{5E5D8AFE-AA8E-30B5-0691-18323048B460}"/>
          </ac:picMkLst>
        </pc:picChg>
        <pc:picChg chg="add mod">
          <ac:chgData name="Woon, Ee Von" userId="1b3820bb-7f14-49a5-83eb-04a96bcdd0d6" providerId="ADAL" clId="{8A041833-A45C-4D5C-9C03-8F95B93AA73B}" dt="2022-12-21T12:54:31.795" v="1729" actId="14100"/>
          <ac:picMkLst>
            <pc:docMk/>
            <pc:sldMk cId="2220380472" sldId="266"/>
            <ac:picMk id="7" creationId="{D00253F7-4421-9E81-CC61-159263D29FC4}"/>
          </ac:picMkLst>
        </pc:pic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96D51C5-CA89-4775-816C-DB89659D4933}" type="datetimeFigureOut">
              <a:rPr lang="en-GB" smtClean="0"/>
              <a:t>21/12/2022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E15421C-B474-43CF-90FA-878A811FCC0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8994347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371600" y="1143000"/>
            <a:ext cx="41148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i="0" dirty="0"/>
              <a:t>Supplementary Figure 1 - </a:t>
            </a:r>
            <a:r>
              <a:rPr lang="en-US" b="0" i="0" dirty="0" err="1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uNK</a:t>
            </a:r>
            <a:r>
              <a:rPr lang="en-US" b="0" i="0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 and </a:t>
            </a:r>
            <a:r>
              <a:rPr lang="en-US" b="0" i="0" dirty="0" err="1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pNK</a:t>
            </a:r>
            <a:r>
              <a:rPr lang="en-US" b="0" i="0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 production of cytokines in unexplained subfertility, recurrent miscarriage and implantation failure compared to controls. </a:t>
            </a:r>
            <a:r>
              <a:rPr lang="en-GB" sz="1200" i="0" dirty="0">
                <a:solidFill>
                  <a:srgbClr val="44546A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Uterine and peripheral NK cells taken from control and UI, RM and RIF groups were cultured with or without PMA and ionomycin stimulation. Representative staining from total </a:t>
            </a:r>
            <a:r>
              <a:rPr lang="en-GB" sz="1200" i="0" dirty="0" err="1">
                <a:solidFill>
                  <a:srgbClr val="44546A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uNK</a:t>
            </a:r>
            <a:r>
              <a:rPr lang="en-GB" sz="1200" i="0" dirty="0">
                <a:solidFill>
                  <a:srgbClr val="44546A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is shown in clear alongside CD3-CD56- internal negative controls in grey </a:t>
            </a:r>
            <a:r>
              <a:rPr lang="en-GB" sz="1200" b="1" i="0" dirty="0">
                <a:solidFill>
                  <a:srgbClr val="44546A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A)</a:t>
            </a:r>
            <a:r>
              <a:rPr lang="en-GB" sz="1200" i="0" dirty="0">
                <a:solidFill>
                  <a:srgbClr val="44546A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r>
              <a:rPr lang="en-GB" sz="1200" b="1" i="0" dirty="0">
                <a:solidFill>
                  <a:srgbClr val="44546A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200" i="0" dirty="0">
                <a:solidFill>
                  <a:srgbClr val="44546A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raphs showing frequencies of IFN-</a:t>
            </a:r>
            <a:r>
              <a:rPr lang="el-GR" sz="1200" i="0" dirty="0">
                <a:solidFill>
                  <a:srgbClr val="44546A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γ</a:t>
            </a:r>
            <a:r>
              <a:rPr lang="en-GB" sz="1200" i="0" dirty="0">
                <a:solidFill>
                  <a:srgbClr val="44546A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i="0" dirty="0"/>
              <a:t> </a:t>
            </a:r>
            <a:r>
              <a:rPr lang="en-GB" b="1" i="0" dirty="0"/>
              <a:t>(B and C)</a:t>
            </a:r>
            <a:r>
              <a:rPr lang="en-GB" sz="1200" i="0" dirty="0">
                <a:solidFill>
                  <a:srgbClr val="44546A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IL-8 </a:t>
            </a:r>
            <a:r>
              <a:rPr lang="en-GB" sz="1200" b="1" i="0" dirty="0">
                <a:solidFill>
                  <a:srgbClr val="44546A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D and E)</a:t>
            </a:r>
            <a:r>
              <a:rPr lang="en-GB" sz="1200" i="0" dirty="0">
                <a:solidFill>
                  <a:srgbClr val="44546A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and GM-CSF </a:t>
            </a:r>
            <a:r>
              <a:rPr lang="en-GB" sz="1200" b="1" i="0" dirty="0">
                <a:solidFill>
                  <a:srgbClr val="44546A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F and G) </a:t>
            </a:r>
            <a:r>
              <a:rPr lang="en-GB" sz="1200" i="0" dirty="0">
                <a:solidFill>
                  <a:srgbClr val="44546A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n unstimulated and stimulated </a:t>
            </a:r>
            <a:r>
              <a:rPr lang="en-GB" sz="1200" i="0" dirty="0" err="1">
                <a:solidFill>
                  <a:srgbClr val="44546A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uNK</a:t>
            </a:r>
            <a:r>
              <a:rPr lang="en-GB" sz="1200" i="0" dirty="0">
                <a:solidFill>
                  <a:srgbClr val="44546A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nd </a:t>
            </a:r>
            <a:r>
              <a:rPr lang="en-GB" sz="1200" i="0" dirty="0" err="1">
                <a:solidFill>
                  <a:srgbClr val="44546A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NK</a:t>
            </a:r>
            <a:r>
              <a:rPr lang="en-GB" sz="1200" i="0" dirty="0">
                <a:solidFill>
                  <a:srgbClr val="44546A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Means and standard deviations are shown for controls (n=11) shown in black and patients from fertility clinic including unexplained infertility (UI; n=9) showed in blue, recurrent miscarriage (RM; n=3) shown in red and recurrent implantation failure (RIF; n=3) shown in green. Statistical testing was done using unpaired t-test for normal or Mann-Whitney U test for non-normal distribution. </a:t>
            </a:r>
          </a:p>
          <a:p>
            <a:endParaRPr lang="en-GB" i="0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E15421C-B474-43CF-90FA-878A811FCC0D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4043580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sz="1200" i="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2 - Graphs showing cytokines in patients who had ongoing pregnancy compared to no ongoing pregnancy. Means and standard deviations are shown for </a:t>
            </a:r>
            <a:r>
              <a:rPr lang="en-GB" sz="1200" b="0" i="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FN-g </a:t>
            </a:r>
            <a:r>
              <a:rPr lang="en-GB" sz="1200" b="1" i="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A and B)</a:t>
            </a:r>
            <a:r>
              <a:rPr lang="en-GB" sz="1200" b="0" i="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IL-8 </a:t>
            </a:r>
            <a:r>
              <a:rPr lang="en-GB" sz="1200" b="1" i="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C and D)</a:t>
            </a:r>
            <a:r>
              <a:rPr lang="en-GB" sz="1200" b="0" i="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nd GM-CSF </a:t>
            </a:r>
            <a:r>
              <a:rPr lang="en-GB" sz="1200" b="1" i="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E and F)</a:t>
            </a:r>
            <a:r>
              <a:rPr lang="en-GB" sz="1200" b="0" i="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with and without</a:t>
            </a:r>
            <a:r>
              <a:rPr lang="en-GB" sz="1200" b="1" i="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200" b="0" i="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timulation.</a:t>
            </a:r>
            <a:r>
              <a:rPr lang="en-GB" sz="1200" i="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800" b="0" i="0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NOP group consist of n=7 who did not become (represented as dots) and n=2 who became pregnant but miscarried (represented as triangles</a:t>
            </a:r>
            <a:r>
              <a:rPr lang="en-GB" sz="1800" b="0" i="0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). U</a:t>
            </a:r>
            <a:r>
              <a:rPr lang="en-GB" sz="1200" i="0" dirty="0">
                <a:solidFill>
                  <a:srgbClr val="44546A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explained infertility (UI) is showed in blue, recurrent miscarriage (RM) is shown in red and recurrent implantation failure (RIF) is shown in green. </a:t>
            </a:r>
          </a:p>
          <a:p>
            <a:endParaRPr lang="en-GB" dirty="0"/>
          </a:p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E15421C-B474-43CF-90FA-878A811FCC0D}" type="slidenum">
              <a:rPr lang="en-GB" smtClean="0"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04187027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dirty="0"/>
              <a:t>Supplementary Figure 3 – CD107a with and without stimulation for controls shown in black (n=11) and fertility patients with unexplained infertility (n=9) shown in blue, recurrent miscarriage (n=4) shown in red and recurrent implantation failure (n=3) shown in green. Statistical testing was done with paired t-tests * p&lt;0.05; **, p&lt;0.01; ***; p&lt;0.0001, ****, p&lt;0.00001. u, unstimulated; s, stimulated.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GB" b="0" i="0" dirty="0">
              <a:solidFill>
                <a:srgbClr val="000000"/>
              </a:solidFill>
              <a:effectLst/>
              <a:latin typeface="Calibri" panose="020F0502020204030204" pitchFamily="34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GB" b="0" i="0" dirty="0">
              <a:solidFill>
                <a:srgbClr val="000000"/>
              </a:solidFill>
              <a:effectLst/>
              <a:latin typeface="Calibri" panose="020F0502020204030204" pitchFamily="34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GB" b="0" i="0" dirty="0">
              <a:solidFill>
                <a:srgbClr val="000000"/>
              </a:solidFill>
              <a:effectLst/>
              <a:latin typeface="Calibri" panose="020F0502020204030204" pitchFamily="34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GB" sz="1200" i="0" dirty="0">
              <a:solidFill>
                <a:srgbClr val="44546A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E15421C-B474-43CF-90FA-878A811FCC0D}" type="slidenum">
              <a:rPr lang="en-GB" smtClean="0"/>
              <a:t>3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70531651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sz="1200" i="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4 - FACS staining to show a representative sample of KIR2DS1 positive in control </a:t>
            </a:r>
            <a:r>
              <a:rPr lang="en-GB" sz="1200" b="1" i="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A) </a:t>
            </a:r>
            <a:r>
              <a:rPr lang="en-GB" sz="1200" i="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nd KIR2DS1 negative in patient </a:t>
            </a:r>
            <a:r>
              <a:rPr lang="en-GB" sz="1200" b="1" i="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B) </a:t>
            </a:r>
            <a:r>
              <a:rPr lang="en-GB" sz="1200" b="0" i="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n total </a:t>
            </a:r>
            <a:r>
              <a:rPr lang="en-GB" sz="1200" b="0" i="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NK</a:t>
            </a:r>
            <a:r>
              <a:rPr lang="en-GB" sz="1200" b="0" i="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endParaRPr lang="en-GB" b="1" dirty="0"/>
          </a:p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E15421C-B474-43CF-90FA-878A811FCC0D}" type="slidenum">
              <a:rPr lang="en-GB" smtClean="0"/>
              <a:t>4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90693710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 dirty="0"/>
              <a:t>Supplementary Table 1 – KIR2DS1 status in patients with reproductive failure (9/16, 56%) compared to controls with no history of reproductive problems (13/20, 65%). Statistical test performed by Fisher’s exact test (p=0.73).</a:t>
            </a:r>
          </a:p>
          <a:p>
            <a:r>
              <a:rPr lang="en-GB" dirty="0"/>
              <a:t>UI, unexplained infertility; RM, recurrent miscarriage; RIF, recurrent implantation failure; +, positive; </a:t>
            </a:r>
            <a:r>
              <a:rPr lang="en-GB"/>
              <a:t>-, negative.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E15421C-B474-43CF-90FA-878A811FCC0D}" type="slidenum">
              <a:rPr lang="en-GB" smtClean="0"/>
              <a:t>5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4905839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219200" y="1995312"/>
            <a:ext cx="13817600" cy="4244622"/>
          </a:xfrm>
        </p:spPr>
        <p:txBody>
          <a:bodyPr anchor="b"/>
          <a:lstStyle>
            <a:lvl1pPr algn="ctr">
              <a:defRPr sz="106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032000" y="6403623"/>
            <a:ext cx="12192000" cy="2943577"/>
          </a:xfrm>
        </p:spPr>
        <p:txBody>
          <a:bodyPr/>
          <a:lstStyle>
            <a:lvl1pPr marL="0" indent="0" algn="ctr">
              <a:buNone/>
              <a:defRPr sz="4267"/>
            </a:lvl1pPr>
            <a:lvl2pPr marL="812810" indent="0" algn="ctr">
              <a:buNone/>
              <a:defRPr sz="3556"/>
            </a:lvl2pPr>
            <a:lvl3pPr marL="1625620" indent="0" algn="ctr">
              <a:buNone/>
              <a:defRPr sz="3200"/>
            </a:lvl3pPr>
            <a:lvl4pPr marL="2438430" indent="0" algn="ctr">
              <a:buNone/>
              <a:defRPr sz="2844"/>
            </a:lvl4pPr>
            <a:lvl5pPr marL="3251241" indent="0" algn="ctr">
              <a:buNone/>
              <a:defRPr sz="2844"/>
            </a:lvl5pPr>
            <a:lvl6pPr marL="4064051" indent="0" algn="ctr">
              <a:buNone/>
              <a:defRPr sz="2844"/>
            </a:lvl6pPr>
            <a:lvl7pPr marL="4876861" indent="0" algn="ctr">
              <a:buNone/>
              <a:defRPr sz="2844"/>
            </a:lvl7pPr>
            <a:lvl8pPr marL="5689671" indent="0" algn="ctr">
              <a:buNone/>
              <a:defRPr sz="2844"/>
            </a:lvl8pPr>
            <a:lvl9pPr marL="6502481" indent="0" algn="ctr">
              <a:buNone/>
              <a:defRPr sz="2844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DF5E14-7FD3-49B8-ADC1-297DA62B47CF}" type="datetimeFigureOut">
              <a:rPr lang="en-GB" smtClean="0"/>
              <a:t>21/12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165C4E-B0B6-4B2D-BB21-C9222592C3B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153163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DF5E14-7FD3-49B8-ADC1-297DA62B47CF}" type="datetimeFigureOut">
              <a:rPr lang="en-GB" smtClean="0"/>
              <a:t>21/12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165C4E-B0B6-4B2D-BB21-C9222592C3B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184148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1633201" y="649111"/>
            <a:ext cx="3505200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117601" y="649111"/>
            <a:ext cx="10312400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DF5E14-7FD3-49B8-ADC1-297DA62B47CF}" type="datetimeFigureOut">
              <a:rPr lang="en-GB" smtClean="0"/>
              <a:t>21/12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165C4E-B0B6-4B2D-BB21-C9222592C3B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223803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DF5E14-7FD3-49B8-ADC1-297DA62B47CF}" type="datetimeFigureOut">
              <a:rPr lang="en-GB" smtClean="0"/>
              <a:t>21/12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165C4E-B0B6-4B2D-BB21-C9222592C3B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97015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09134" y="3039537"/>
            <a:ext cx="14020800" cy="5071532"/>
          </a:xfrm>
        </p:spPr>
        <p:txBody>
          <a:bodyPr anchor="b"/>
          <a:lstStyle>
            <a:lvl1pPr>
              <a:defRPr sz="106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09134" y="8159048"/>
            <a:ext cx="14020800" cy="2666999"/>
          </a:xfrm>
        </p:spPr>
        <p:txBody>
          <a:bodyPr/>
          <a:lstStyle>
            <a:lvl1pPr marL="0" indent="0">
              <a:buNone/>
              <a:defRPr sz="4267">
                <a:solidFill>
                  <a:schemeClr val="tx1"/>
                </a:solidFill>
              </a:defRPr>
            </a:lvl1pPr>
            <a:lvl2pPr marL="812810" indent="0">
              <a:buNone/>
              <a:defRPr sz="3556">
                <a:solidFill>
                  <a:schemeClr val="tx1">
                    <a:tint val="75000"/>
                  </a:schemeClr>
                </a:solidFill>
              </a:defRPr>
            </a:lvl2pPr>
            <a:lvl3pPr marL="162562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3pPr>
            <a:lvl4pPr marL="2438430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4pPr>
            <a:lvl5pPr marL="3251241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5pPr>
            <a:lvl6pPr marL="4064051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6pPr>
            <a:lvl7pPr marL="4876861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7pPr>
            <a:lvl8pPr marL="5689671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8pPr>
            <a:lvl9pPr marL="6502481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DF5E14-7FD3-49B8-ADC1-297DA62B47CF}" type="datetimeFigureOut">
              <a:rPr lang="en-GB" smtClean="0"/>
              <a:t>21/12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165C4E-B0B6-4B2D-BB21-C9222592C3B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07315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117600" y="3245556"/>
            <a:ext cx="690880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229600" y="3245556"/>
            <a:ext cx="690880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DF5E14-7FD3-49B8-ADC1-297DA62B47CF}" type="datetimeFigureOut">
              <a:rPr lang="en-GB" smtClean="0"/>
              <a:t>21/12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165C4E-B0B6-4B2D-BB21-C9222592C3B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806395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9717" y="649114"/>
            <a:ext cx="14020800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19719" y="2988734"/>
            <a:ext cx="6877049" cy="1464732"/>
          </a:xfrm>
        </p:spPr>
        <p:txBody>
          <a:bodyPr anchor="b"/>
          <a:lstStyle>
            <a:lvl1pPr marL="0" indent="0">
              <a:buNone/>
              <a:defRPr sz="4267" b="1"/>
            </a:lvl1pPr>
            <a:lvl2pPr marL="812810" indent="0">
              <a:buNone/>
              <a:defRPr sz="3556" b="1"/>
            </a:lvl2pPr>
            <a:lvl3pPr marL="1625620" indent="0">
              <a:buNone/>
              <a:defRPr sz="3200" b="1"/>
            </a:lvl3pPr>
            <a:lvl4pPr marL="2438430" indent="0">
              <a:buNone/>
              <a:defRPr sz="2844" b="1"/>
            </a:lvl4pPr>
            <a:lvl5pPr marL="3251241" indent="0">
              <a:buNone/>
              <a:defRPr sz="2844" b="1"/>
            </a:lvl5pPr>
            <a:lvl6pPr marL="4064051" indent="0">
              <a:buNone/>
              <a:defRPr sz="2844" b="1"/>
            </a:lvl6pPr>
            <a:lvl7pPr marL="4876861" indent="0">
              <a:buNone/>
              <a:defRPr sz="2844" b="1"/>
            </a:lvl7pPr>
            <a:lvl8pPr marL="5689671" indent="0">
              <a:buNone/>
              <a:defRPr sz="2844" b="1"/>
            </a:lvl8pPr>
            <a:lvl9pPr marL="6502481" indent="0">
              <a:buNone/>
              <a:defRPr sz="2844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119719" y="4453467"/>
            <a:ext cx="6877049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8229601" y="2988734"/>
            <a:ext cx="6910917" cy="1464732"/>
          </a:xfrm>
        </p:spPr>
        <p:txBody>
          <a:bodyPr anchor="b"/>
          <a:lstStyle>
            <a:lvl1pPr marL="0" indent="0">
              <a:buNone/>
              <a:defRPr sz="4267" b="1"/>
            </a:lvl1pPr>
            <a:lvl2pPr marL="812810" indent="0">
              <a:buNone/>
              <a:defRPr sz="3556" b="1"/>
            </a:lvl2pPr>
            <a:lvl3pPr marL="1625620" indent="0">
              <a:buNone/>
              <a:defRPr sz="3200" b="1"/>
            </a:lvl3pPr>
            <a:lvl4pPr marL="2438430" indent="0">
              <a:buNone/>
              <a:defRPr sz="2844" b="1"/>
            </a:lvl4pPr>
            <a:lvl5pPr marL="3251241" indent="0">
              <a:buNone/>
              <a:defRPr sz="2844" b="1"/>
            </a:lvl5pPr>
            <a:lvl6pPr marL="4064051" indent="0">
              <a:buNone/>
              <a:defRPr sz="2844" b="1"/>
            </a:lvl6pPr>
            <a:lvl7pPr marL="4876861" indent="0">
              <a:buNone/>
              <a:defRPr sz="2844" b="1"/>
            </a:lvl7pPr>
            <a:lvl8pPr marL="5689671" indent="0">
              <a:buNone/>
              <a:defRPr sz="2844" b="1"/>
            </a:lvl8pPr>
            <a:lvl9pPr marL="6502481" indent="0">
              <a:buNone/>
              <a:defRPr sz="2844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8229601" y="4453467"/>
            <a:ext cx="6910917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DF5E14-7FD3-49B8-ADC1-297DA62B47CF}" type="datetimeFigureOut">
              <a:rPr lang="en-GB" smtClean="0"/>
              <a:t>21/12/2022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165C4E-B0B6-4B2D-BB21-C9222592C3B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764536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DF5E14-7FD3-49B8-ADC1-297DA62B47CF}" type="datetimeFigureOut">
              <a:rPr lang="en-GB" smtClean="0"/>
              <a:t>21/12/2022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165C4E-B0B6-4B2D-BB21-C9222592C3B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424656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DF5E14-7FD3-49B8-ADC1-297DA62B47CF}" type="datetimeFigureOut">
              <a:rPr lang="en-GB" smtClean="0"/>
              <a:t>21/12/2022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165C4E-B0B6-4B2D-BB21-C9222592C3B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089279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9717" y="812800"/>
            <a:ext cx="5242983" cy="2844800"/>
          </a:xfrm>
        </p:spPr>
        <p:txBody>
          <a:bodyPr anchor="b"/>
          <a:lstStyle>
            <a:lvl1pPr>
              <a:defRPr sz="568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910917" y="1755425"/>
            <a:ext cx="8229600" cy="8664222"/>
          </a:xfrm>
        </p:spPr>
        <p:txBody>
          <a:bodyPr/>
          <a:lstStyle>
            <a:lvl1pPr>
              <a:defRPr sz="5689"/>
            </a:lvl1pPr>
            <a:lvl2pPr>
              <a:defRPr sz="4978"/>
            </a:lvl2pPr>
            <a:lvl3pPr>
              <a:defRPr sz="4267"/>
            </a:lvl3pPr>
            <a:lvl4pPr>
              <a:defRPr sz="3556"/>
            </a:lvl4pPr>
            <a:lvl5pPr>
              <a:defRPr sz="3556"/>
            </a:lvl5pPr>
            <a:lvl6pPr>
              <a:defRPr sz="3556"/>
            </a:lvl6pPr>
            <a:lvl7pPr>
              <a:defRPr sz="3556"/>
            </a:lvl7pPr>
            <a:lvl8pPr>
              <a:defRPr sz="3556"/>
            </a:lvl8pPr>
            <a:lvl9pPr>
              <a:defRPr sz="3556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19717" y="3657600"/>
            <a:ext cx="5242983" cy="6776156"/>
          </a:xfrm>
        </p:spPr>
        <p:txBody>
          <a:bodyPr/>
          <a:lstStyle>
            <a:lvl1pPr marL="0" indent="0">
              <a:buNone/>
              <a:defRPr sz="2844"/>
            </a:lvl1pPr>
            <a:lvl2pPr marL="812810" indent="0">
              <a:buNone/>
              <a:defRPr sz="2489"/>
            </a:lvl2pPr>
            <a:lvl3pPr marL="1625620" indent="0">
              <a:buNone/>
              <a:defRPr sz="2133"/>
            </a:lvl3pPr>
            <a:lvl4pPr marL="2438430" indent="0">
              <a:buNone/>
              <a:defRPr sz="1778"/>
            </a:lvl4pPr>
            <a:lvl5pPr marL="3251241" indent="0">
              <a:buNone/>
              <a:defRPr sz="1778"/>
            </a:lvl5pPr>
            <a:lvl6pPr marL="4064051" indent="0">
              <a:buNone/>
              <a:defRPr sz="1778"/>
            </a:lvl6pPr>
            <a:lvl7pPr marL="4876861" indent="0">
              <a:buNone/>
              <a:defRPr sz="1778"/>
            </a:lvl7pPr>
            <a:lvl8pPr marL="5689671" indent="0">
              <a:buNone/>
              <a:defRPr sz="1778"/>
            </a:lvl8pPr>
            <a:lvl9pPr marL="6502481" indent="0">
              <a:buNone/>
              <a:defRPr sz="1778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DF5E14-7FD3-49B8-ADC1-297DA62B47CF}" type="datetimeFigureOut">
              <a:rPr lang="en-GB" smtClean="0"/>
              <a:t>21/12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165C4E-B0B6-4B2D-BB21-C9222592C3B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781163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9717" y="812800"/>
            <a:ext cx="5242983" cy="2844800"/>
          </a:xfrm>
        </p:spPr>
        <p:txBody>
          <a:bodyPr anchor="b"/>
          <a:lstStyle>
            <a:lvl1pPr>
              <a:defRPr sz="568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6910917" y="1755425"/>
            <a:ext cx="8229600" cy="8664222"/>
          </a:xfrm>
        </p:spPr>
        <p:txBody>
          <a:bodyPr anchor="t"/>
          <a:lstStyle>
            <a:lvl1pPr marL="0" indent="0">
              <a:buNone/>
              <a:defRPr sz="5689"/>
            </a:lvl1pPr>
            <a:lvl2pPr marL="812810" indent="0">
              <a:buNone/>
              <a:defRPr sz="4978"/>
            </a:lvl2pPr>
            <a:lvl3pPr marL="1625620" indent="0">
              <a:buNone/>
              <a:defRPr sz="4267"/>
            </a:lvl3pPr>
            <a:lvl4pPr marL="2438430" indent="0">
              <a:buNone/>
              <a:defRPr sz="3556"/>
            </a:lvl4pPr>
            <a:lvl5pPr marL="3251241" indent="0">
              <a:buNone/>
              <a:defRPr sz="3556"/>
            </a:lvl5pPr>
            <a:lvl6pPr marL="4064051" indent="0">
              <a:buNone/>
              <a:defRPr sz="3556"/>
            </a:lvl6pPr>
            <a:lvl7pPr marL="4876861" indent="0">
              <a:buNone/>
              <a:defRPr sz="3556"/>
            </a:lvl7pPr>
            <a:lvl8pPr marL="5689671" indent="0">
              <a:buNone/>
              <a:defRPr sz="3556"/>
            </a:lvl8pPr>
            <a:lvl9pPr marL="6502481" indent="0">
              <a:buNone/>
              <a:defRPr sz="3556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19717" y="3657600"/>
            <a:ext cx="5242983" cy="6776156"/>
          </a:xfrm>
        </p:spPr>
        <p:txBody>
          <a:bodyPr/>
          <a:lstStyle>
            <a:lvl1pPr marL="0" indent="0">
              <a:buNone/>
              <a:defRPr sz="2844"/>
            </a:lvl1pPr>
            <a:lvl2pPr marL="812810" indent="0">
              <a:buNone/>
              <a:defRPr sz="2489"/>
            </a:lvl2pPr>
            <a:lvl3pPr marL="1625620" indent="0">
              <a:buNone/>
              <a:defRPr sz="2133"/>
            </a:lvl3pPr>
            <a:lvl4pPr marL="2438430" indent="0">
              <a:buNone/>
              <a:defRPr sz="1778"/>
            </a:lvl4pPr>
            <a:lvl5pPr marL="3251241" indent="0">
              <a:buNone/>
              <a:defRPr sz="1778"/>
            </a:lvl5pPr>
            <a:lvl6pPr marL="4064051" indent="0">
              <a:buNone/>
              <a:defRPr sz="1778"/>
            </a:lvl6pPr>
            <a:lvl7pPr marL="4876861" indent="0">
              <a:buNone/>
              <a:defRPr sz="1778"/>
            </a:lvl7pPr>
            <a:lvl8pPr marL="5689671" indent="0">
              <a:buNone/>
              <a:defRPr sz="1778"/>
            </a:lvl8pPr>
            <a:lvl9pPr marL="6502481" indent="0">
              <a:buNone/>
              <a:defRPr sz="1778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DF5E14-7FD3-49B8-ADC1-297DA62B47CF}" type="datetimeFigureOut">
              <a:rPr lang="en-GB" smtClean="0"/>
              <a:t>21/12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165C4E-B0B6-4B2D-BB21-C9222592C3B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829912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117600" y="649114"/>
            <a:ext cx="14020800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17600" y="3245556"/>
            <a:ext cx="14020800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117600" y="11300181"/>
            <a:ext cx="365760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1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DF5E14-7FD3-49B8-ADC1-297DA62B47CF}" type="datetimeFigureOut">
              <a:rPr lang="en-GB" smtClean="0"/>
              <a:t>21/12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384800" y="11300181"/>
            <a:ext cx="548640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1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1480800" y="11300181"/>
            <a:ext cx="365760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1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165C4E-B0B6-4B2D-BB21-C9222592C3B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759694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1625620" rtl="0" eaLnBrk="1" latinLnBrk="0" hangingPunct="1">
        <a:lnSpc>
          <a:spcPct val="90000"/>
        </a:lnSpc>
        <a:spcBef>
          <a:spcPct val="0"/>
        </a:spcBef>
        <a:buNone/>
        <a:defRPr sz="782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06405" indent="-406405" algn="l" defTabSz="1625620" rtl="0" eaLnBrk="1" latinLnBrk="0" hangingPunct="1">
        <a:lnSpc>
          <a:spcPct val="90000"/>
        </a:lnSpc>
        <a:spcBef>
          <a:spcPts val="1778"/>
        </a:spcBef>
        <a:buFont typeface="Arial" panose="020B0604020202020204" pitchFamily="34" charset="0"/>
        <a:buChar char="•"/>
        <a:defRPr sz="4978" kern="1200">
          <a:solidFill>
            <a:schemeClr val="tx1"/>
          </a:solidFill>
          <a:latin typeface="+mn-lt"/>
          <a:ea typeface="+mn-ea"/>
          <a:cs typeface="+mn-cs"/>
        </a:defRPr>
      </a:lvl1pPr>
      <a:lvl2pPr marL="1219215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4267" kern="1200">
          <a:solidFill>
            <a:schemeClr val="tx1"/>
          </a:solidFill>
          <a:latin typeface="+mn-lt"/>
          <a:ea typeface="+mn-ea"/>
          <a:cs typeface="+mn-cs"/>
        </a:defRPr>
      </a:lvl2pPr>
      <a:lvl3pPr marL="2032025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556" kern="1200">
          <a:solidFill>
            <a:schemeClr val="tx1"/>
          </a:solidFill>
          <a:latin typeface="+mn-lt"/>
          <a:ea typeface="+mn-ea"/>
          <a:cs typeface="+mn-cs"/>
        </a:defRPr>
      </a:lvl3pPr>
      <a:lvl4pPr marL="284483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4pPr>
      <a:lvl5pPr marL="365764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5pPr>
      <a:lvl6pPr marL="447045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6pPr>
      <a:lvl7pPr marL="528326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7pPr>
      <a:lvl8pPr marL="609607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8pPr>
      <a:lvl9pPr marL="690888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812810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625620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3pPr>
      <a:lvl4pPr marL="2438430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4pPr>
      <a:lvl5pPr marL="3251241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5pPr>
      <a:lvl6pPr marL="4064051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6pPr>
      <a:lvl7pPr marL="4876861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7pPr>
      <a:lvl8pPr marL="5689671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8pPr>
      <a:lvl9pPr marL="6502481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bmp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9" descr="Diagram&#10;&#10;Description automatically generated">
            <a:extLst>
              <a:ext uri="{FF2B5EF4-FFF2-40B4-BE49-F238E27FC236}">
                <a16:creationId xmlns:a16="http://schemas.microsoft.com/office/drawing/2014/main" id="{27F1E9CB-FE72-8365-DC7F-923727905F99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64515" y="0"/>
            <a:ext cx="6726969" cy="12192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8488231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gram&#10;&#10;Description automatically generated">
            <a:extLst>
              <a:ext uri="{FF2B5EF4-FFF2-40B4-BE49-F238E27FC236}">
                <a16:creationId xmlns:a16="http://schemas.microsoft.com/office/drawing/2014/main" id="{7C0845A5-0CB7-D9AF-760C-E780B806C44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25574" y="0"/>
            <a:ext cx="7204852" cy="12192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8178098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gram, engineering drawing&#10;&#10;Description automatically generated">
            <a:extLst>
              <a:ext uri="{FF2B5EF4-FFF2-40B4-BE49-F238E27FC236}">
                <a16:creationId xmlns:a16="http://schemas.microsoft.com/office/drawing/2014/main" id="{D00253F7-4421-9E81-CC61-159263D29FC4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6358" y="1161244"/>
            <a:ext cx="14718596" cy="871902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2038047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Diagram, schematic&#10;&#10;Description automatically generated">
            <a:extLst>
              <a:ext uri="{FF2B5EF4-FFF2-40B4-BE49-F238E27FC236}">
                <a16:creationId xmlns:a16="http://schemas.microsoft.com/office/drawing/2014/main" id="{D97E3118-4F65-DB5C-4D39-39CC0EB033E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88102" y="2910935"/>
            <a:ext cx="11261620" cy="496240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3691233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2">
            <a:extLst>
              <a:ext uri="{FF2B5EF4-FFF2-40B4-BE49-F238E27FC236}">
                <a16:creationId xmlns:a16="http://schemas.microsoft.com/office/drawing/2014/main" id="{8C1537B2-D6AB-7222-CF09-1746BE4CC8A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21078156"/>
              </p:ext>
            </p:extLst>
          </p:nvPr>
        </p:nvGraphicFramePr>
        <p:xfrm>
          <a:off x="2091817" y="144117"/>
          <a:ext cx="13500484" cy="11790568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3375121">
                  <a:extLst>
                    <a:ext uri="{9D8B030D-6E8A-4147-A177-3AD203B41FA5}">
                      <a16:colId xmlns:a16="http://schemas.microsoft.com/office/drawing/2014/main" val="3217692404"/>
                    </a:ext>
                  </a:extLst>
                </a:gridCol>
                <a:gridCol w="3375121">
                  <a:extLst>
                    <a:ext uri="{9D8B030D-6E8A-4147-A177-3AD203B41FA5}">
                      <a16:colId xmlns:a16="http://schemas.microsoft.com/office/drawing/2014/main" val="3637974494"/>
                    </a:ext>
                  </a:extLst>
                </a:gridCol>
                <a:gridCol w="3375121">
                  <a:extLst>
                    <a:ext uri="{9D8B030D-6E8A-4147-A177-3AD203B41FA5}">
                      <a16:colId xmlns:a16="http://schemas.microsoft.com/office/drawing/2014/main" val="3840608187"/>
                    </a:ext>
                  </a:extLst>
                </a:gridCol>
                <a:gridCol w="3375121">
                  <a:extLst>
                    <a:ext uri="{9D8B030D-6E8A-4147-A177-3AD203B41FA5}">
                      <a16:colId xmlns:a16="http://schemas.microsoft.com/office/drawing/2014/main" val="907031172"/>
                    </a:ext>
                  </a:extLst>
                </a:gridCol>
              </a:tblGrid>
              <a:tr h="318664"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endParaRPr lang="en-GB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ravida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rity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IR2DS1 status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86097556"/>
                  </a:ext>
                </a:extLst>
              </a:tr>
              <a:tr h="318664"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GB" sz="10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UI</a:t>
                      </a:r>
                      <a:endParaRPr lang="en-GB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255" marR="8255" marT="82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en-GB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01" marR="8501" marT="850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en-GB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01" marR="8501" marT="850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GB" sz="10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en-GB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9866012"/>
                  </a:ext>
                </a:extLst>
              </a:tr>
              <a:tr h="318664"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GB" sz="10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UI</a:t>
                      </a:r>
                      <a:endParaRPr lang="en-GB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255" marR="8255" marT="82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en-GB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01" marR="8501" marT="850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en-GB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01" marR="8501" marT="850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GB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endParaRPr lang="en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4569309"/>
                  </a:ext>
                </a:extLst>
              </a:tr>
              <a:tr h="318664"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GB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UI</a:t>
                      </a:r>
                      <a:endParaRPr lang="en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255" marR="8255" marT="82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en-GB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01" marR="8501" marT="850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en-GB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01" marR="8501" marT="850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GB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endParaRPr lang="en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6667373"/>
                  </a:ext>
                </a:extLst>
              </a:tr>
              <a:tr h="318664"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GB" sz="10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UI</a:t>
                      </a:r>
                      <a:endParaRPr lang="en-GB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255" marR="8255" marT="82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en-GB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01" marR="8501" marT="850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en-GB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01" marR="8501" marT="850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GB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endParaRPr lang="en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03146554"/>
                  </a:ext>
                </a:extLst>
              </a:tr>
              <a:tr h="318664"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GB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UI</a:t>
                      </a:r>
                      <a:endParaRPr lang="en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255" marR="8255" marT="82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en-GB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01" marR="8501" marT="850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en-GB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01" marR="8501" marT="850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GB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endParaRPr lang="en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29623230"/>
                  </a:ext>
                </a:extLst>
              </a:tr>
              <a:tr h="318664"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GB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UI</a:t>
                      </a:r>
                      <a:endParaRPr lang="en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255" marR="8255" marT="82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en-GB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01" marR="8501" marT="850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en-GB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01" marR="8501" marT="850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GB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en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23028708"/>
                  </a:ext>
                </a:extLst>
              </a:tr>
              <a:tr h="318664"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GB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UI</a:t>
                      </a:r>
                      <a:endParaRPr lang="en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255" marR="8255" marT="82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en-GB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01" marR="8501" marT="850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en-GB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01" marR="8501" marT="850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GB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endParaRPr lang="en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53838462"/>
                  </a:ext>
                </a:extLst>
              </a:tr>
              <a:tr h="318664"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GB" sz="10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UI</a:t>
                      </a:r>
                      <a:endParaRPr lang="en-GB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255" marR="8255" marT="82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en-GB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01" marR="8501" marT="850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en-GB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01" marR="8501" marT="850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GB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endParaRPr lang="en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08889504"/>
                  </a:ext>
                </a:extLst>
              </a:tr>
              <a:tr h="318664"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GB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UI</a:t>
                      </a:r>
                      <a:endParaRPr lang="en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255" marR="8255" marT="82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en-GB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01" marR="8501" marT="850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en-GB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01" marR="8501" marT="850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GB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en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75766802"/>
                  </a:ext>
                </a:extLst>
              </a:tr>
              <a:tr h="318664"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GB" sz="10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M</a:t>
                      </a:r>
                      <a:endParaRPr lang="en-GB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255" marR="8255" marT="82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en-GB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01" marR="8501" marT="850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en-GB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01" marR="8501" marT="850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en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09830592"/>
                  </a:ext>
                </a:extLst>
              </a:tr>
              <a:tr h="318664"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GB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M</a:t>
                      </a:r>
                      <a:endParaRPr lang="en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255" marR="8255" marT="82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en-GB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01" marR="8501" marT="850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en-GB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01" marR="8501" marT="850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GB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en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15228326"/>
                  </a:ext>
                </a:extLst>
              </a:tr>
              <a:tr h="318664"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GB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M</a:t>
                      </a:r>
                      <a:endParaRPr lang="en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255" marR="8255" marT="82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en-GB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01" marR="8501" marT="850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en-GB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01" marR="8501" marT="850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GB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endParaRPr lang="en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5139137"/>
                  </a:ext>
                </a:extLst>
              </a:tr>
              <a:tr h="318664"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GB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M</a:t>
                      </a:r>
                      <a:endParaRPr lang="en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255" marR="8255" marT="82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en-GB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01" marR="8501" marT="850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en-GB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01" marR="8501" marT="850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GB" sz="10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endParaRPr lang="en-GB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98954965"/>
                  </a:ext>
                </a:extLst>
              </a:tr>
              <a:tr h="318664"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GB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IF</a:t>
                      </a:r>
                      <a:endParaRPr lang="en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255" marR="8255" marT="82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en-GB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01" marR="8501" marT="850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en-GB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01" marR="8501" marT="850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GB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en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57364236"/>
                  </a:ext>
                </a:extLst>
              </a:tr>
              <a:tr h="318664"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GB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IF+UI</a:t>
                      </a:r>
                      <a:endParaRPr lang="en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255" marR="8255" marT="82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en-GB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01" marR="8501" marT="850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en-GB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01" marR="8501" marT="850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GB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endParaRPr lang="en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51748562"/>
                  </a:ext>
                </a:extLst>
              </a:tr>
              <a:tr h="318664"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GB" sz="10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IF+RM</a:t>
                      </a:r>
                      <a:endParaRPr lang="en-GB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255" marR="8255" marT="82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en-GB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01" marR="8501" marT="850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en-GB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01" marR="8501" marT="850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GB" sz="10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en-GB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75049917"/>
                  </a:ext>
                </a:extLst>
              </a:tr>
              <a:tr h="318664"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ntrol’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6080536"/>
                  </a:ext>
                </a:extLst>
              </a:tr>
              <a:tr h="318664"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ntrol’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16477656"/>
                  </a:ext>
                </a:extLst>
              </a:tr>
              <a:tr h="318664"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ntrol’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58880622"/>
                  </a:ext>
                </a:extLst>
              </a:tr>
              <a:tr h="318664">
                <a:tc>
                  <a:txBody>
                    <a:bodyPr/>
                    <a:lstStyle/>
                    <a:p>
                      <a:pPr marL="0" marR="0" lvl="0" indent="0" algn="ctr" defTabSz="162562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ntrol’</a:t>
                      </a:r>
                    </a:p>
                    <a:p>
                      <a:pPr algn="ctr" fontAlgn="b">
                        <a:lnSpc>
                          <a:spcPct val="100000"/>
                        </a:lnSpc>
                      </a:pP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13562770"/>
                  </a:ext>
                </a:extLst>
              </a:tr>
              <a:tr h="318664">
                <a:tc>
                  <a:txBody>
                    <a:bodyPr/>
                    <a:lstStyle/>
                    <a:p>
                      <a:pPr marL="0" marR="0" lvl="0" indent="0" algn="ctr" defTabSz="162562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ntrol’</a:t>
                      </a:r>
                    </a:p>
                    <a:p>
                      <a:pPr algn="ctr" fontAlgn="b">
                        <a:lnSpc>
                          <a:spcPct val="100000"/>
                        </a:lnSpc>
                      </a:pP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20953308"/>
                  </a:ext>
                </a:extLst>
              </a:tr>
              <a:tr h="318664">
                <a:tc>
                  <a:txBody>
                    <a:bodyPr/>
                    <a:lstStyle/>
                    <a:p>
                      <a:pPr marL="0" marR="0" lvl="0" indent="0" algn="ctr" defTabSz="162562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ntrol’</a:t>
                      </a:r>
                    </a:p>
                    <a:p>
                      <a:pPr algn="ctr" fontAlgn="b">
                        <a:lnSpc>
                          <a:spcPct val="100000"/>
                        </a:lnSpc>
                      </a:pP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31010652"/>
                  </a:ext>
                </a:extLst>
              </a:tr>
              <a:tr h="318664">
                <a:tc>
                  <a:txBody>
                    <a:bodyPr/>
                    <a:lstStyle/>
                    <a:p>
                      <a:pPr marL="0" marR="0" lvl="0" indent="0" algn="ctr" defTabSz="162562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ntrol’</a:t>
                      </a:r>
                    </a:p>
                    <a:p>
                      <a:pPr algn="ctr" fontAlgn="b">
                        <a:lnSpc>
                          <a:spcPct val="100000"/>
                        </a:lnSpc>
                      </a:pP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19323996"/>
                  </a:ext>
                </a:extLst>
              </a:tr>
              <a:tr h="318664">
                <a:tc>
                  <a:txBody>
                    <a:bodyPr/>
                    <a:lstStyle/>
                    <a:p>
                      <a:pPr marL="0" marR="0" lvl="0" indent="0" algn="ctr" defTabSz="162562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ntrol’</a:t>
                      </a:r>
                    </a:p>
                    <a:p>
                      <a:pPr algn="ctr" fontAlgn="b">
                        <a:lnSpc>
                          <a:spcPct val="100000"/>
                        </a:lnSpc>
                      </a:pP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03389780"/>
                  </a:ext>
                </a:extLst>
              </a:tr>
              <a:tr h="318664">
                <a:tc>
                  <a:txBody>
                    <a:bodyPr/>
                    <a:lstStyle/>
                    <a:p>
                      <a:pPr marL="0" marR="0" lvl="0" indent="0" algn="ctr" defTabSz="162562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ntrol’</a:t>
                      </a:r>
                    </a:p>
                    <a:p>
                      <a:pPr algn="ctr" fontAlgn="b">
                        <a:lnSpc>
                          <a:spcPct val="100000"/>
                        </a:lnSpc>
                      </a:pP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52334451"/>
                  </a:ext>
                </a:extLst>
              </a:tr>
              <a:tr h="318664">
                <a:tc>
                  <a:txBody>
                    <a:bodyPr/>
                    <a:lstStyle/>
                    <a:p>
                      <a:pPr marL="0" marR="0" lvl="0" indent="0" algn="ctr" defTabSz="162562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ntrol’</a:t>
                      </a:r>
                    </a:p>
                    <a:p>
                      <a:pPr algn="ctr" fontAlgn="b">
                        <a:lnSpc>
                          <a:spcPct val="100000"/>
                        </a:lnSpc>
                      </a:pP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390055"/>
                  </a:ext>
                </a:extLst>
              </a:tr>
              <a:tr h="318664">
                <a:tc>
                  <a:txBody>
                    <a:bodyPr/>
                    <a:lstStyle/>
                    <a:p>
                      <a:pPr marL="0" marR="0" lvl="0" indent="0" algn="ctr" defTabSz="162562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ntrol’</a:t>
                      </a:r>
                    </a:p>
                    <a:p>
                      <a:pPr algn="ctr" fontAlgn="b">
                        <a:lnSpc>
                          <a:spcPct val="100000"/>
                        </a:lnSpc>
                      </a:pP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66875577"/>
                  </a:ext>
                </a:extLst>
              </a:tr>
              <a:tr h="318664">
                <a:tc>
                  <a:txBody>
                    <a:bodyPr/>
                    <a:lstStyle/>
                    <a:p>
                      <a:pPr marL="0" marR="0" lvl="0" indent="0" algn="ctr" defTabSz="162562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ntrol’</a:t>
                      </a:r>
                    </a:p>
                    <a:p>
                      <a:pPr algn="ctr" fontAlgn="b">
                        <a:lnSpc>
                          <a:spcPct val="100000"/>
                        </a:lnSpc>
                      </a:pP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66285024"/>
                  </a:ext>
                </a:extLst>
              </a:tr>
              <a:tr h="318664">
                <a:tc>
                  <a:txBody>
                    <a:bodyPr/>
                    <a:lstStyle/>
                    <a:p>
                      <a:pPr marL="0" marR="0" lvl="0" indent="0" algn="ctr" defTabSz="162562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ntrol’</a:t>
                      </a:r>
                    </a:p>
                    <a:p>
                      <a:pPr algn="ctr" fontAlgn="b">
                        <a:lnSpc>
                          <a:spcPct val="100000"/>
                        </a:lnSpc>
                      </a:pP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80725464"/>
                  </a:ext>
                </a:extLst>
              </a:tr>
              <a:tr h="318664">
                <a:tc>
                  <a:txBody>
                    <a:bodyPr/>
                    <a:lstStyle/>
                    <a:p>
                      <a:pPr marL="0" marR="0" lvl="0" indent="0" algn="ctr" defTabSz="162562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ntrol’</a:t>
                      </a:r>
                    </a:p>
                    <a:p>
                      <a:pPr algn="ctr" fontAlgn="b">
                        <a:lnSpc>
                          <a:spcPct val="100000"/>
                        </a:lnSpc>
                      </a:pP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14996224"/>
                  </a:ext>
                </a:extLst>
              </a:tr>
              <a:tr h="318664">
                <a:tc>
                  <a:txBody>
                    <a:bodyPr/>
                    <a:lstStyle/>
                    <a:p>
                      <a:pPr marL="0" marR="0" lvl="0" indent="0" algn="ctr" defTabSz="162562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ntrol’</a:t>
                      </a:r>
                    </a:p>
                    <a:p>
                      <a:pPr algn="ctr" fontAlgn="b">
                        <a:lnSpc>
                          <a:spcPct val="100000"/>
                        </a:lnSpc>
                      </a:pP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52065251"/>
                  </a:ext>
                </a:extLst>
              </a:tr>
              <a:tr h="318664">
                <a:tc>
                  <a:txBody>
                    <a:bodyPr/>
                    <a:lstStyle/>
                    <a:p>
                      <a:pPr marL="0" marR="0" lvl="0" indent="0" algn="ctr" defTabSz="162562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ntrol’</a:t>
                      </a:r>
                    </a:p>
                    <a:p>
                      <a:pPr algn="ctr" fontAlgn="b">
                        <a:lnSpc>
                          <a:spcPct val="100000"/>
                        </a:lnSpc>
                      </a:pP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50776197"/>
                  </a:ext>
                </a:extLst>
              </a:tr>
              <a:tr h="318664">
                <a:tc>
                  <a:txBody>
                    <a:bodyPr/>
                    <a:lstStyle/>
                    <a:p>
                      <a:pPr marL="0" marR="0" lvl="0" indent="0" algn="ctr" defTabSz="162562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ntrol’</a:t>
                      </a:r>
                    </a:p>
                    <a:p>
                      <a:pPr algn="ctr" fontAlgn="b">
                        <a:lnSpc>
                          <a:spcPct val="100000"/>
                        </a:lnSpc>
                      </a:pP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33375392"/>
                  </a:ext>
                </a:extLst>
              </a:tr>
              <a:tr h="318664">
                <a:tc>
                  <a:txBody>
                    <a:bodyPr/>
                    <a:lstStyle/>
                    <a:p>
                      <a:pPr marL="0" marR="0" lvl="0" indent="0" algn="ctr" defTabSz="162562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ntrol’</a:t>
                      </a:r>
                    </a:p>
                    <a:p>
                      <a:pPr algn="ctr" fontAlgn="b">
                        <a:lnSpc>
                          <a:spcPct val="100000"/>
                        </a:lnSpc>
                      </a:pP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65923351"/>
                  </a:ext>
                </a:extLst>
              </a:tr>
              <a:tr h="318664">
                <a:tc>
                  <a:txBody>
                    <a:bodyPr/>
                    <a:lstStyle/>
                    <a:p>
                      <a:pPr marL="0" marR="0" lvl="0" indent="0" algn="ctr" defTabSz="162562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ntrol’</a:t>
                      </a:r>
                    </a:p>
                    <a:p>
                      <a:pPr algn="ctr" fontAlgn="b">
                        <a:lnSpc>
                          <a:spcPct val="100000"/>
                        </a:lnSpc>
                      </a:pP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10376751"/>
                  </a:ext>
                </a:extLst>
              </a:tr>
              <a:tr h="318664">
                <a:tc>
                  <a:txBody>
                    <a:bodyPr/>
                    <a:lstStyle/>
                    <a:p>
                      <a:pPr marL="0" marR="0" lvl="0" indent="0" algn="ctr" defTabSz="162562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ntrol’</a:t>
                      </a:r>
                    </a:p>
                    <a:p>
                      <a:pPr algn="ctr" fontAlgn="b">
                        <a:lnSpc>
                          <a:spcPct val="100000"/>
                        </a:lnSpc>
                      </a:pP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0742244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67380423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745</TotalTime>
  <Words>653</Words>
  <Application>Microsoft Office PowerPoint</Application>
  <PresentationFormat>Custom</PresentationFormat>
  <Paragraphs>161</Paragraphs>
  <Slides>5</Slides>
  <Notes>5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oon, Ee Von</dc:creator>
  <cp:lastModifiedBy>Woon, Ee Von</cp:lastModifiedBy>
  <cp:revision>2</cp:revision>
  <dcterms:created xsi:type="dcterms:W3CDTF">2022-11-14T23:46:00Z</dcterms:created>
  <dcterms:modified xsi:type="dcterms:W3CDTF">2022-12-21T16:44:01Z</dcterms:modified>
</cp:coreProperties>
</file>